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9" r:id="rId14"/>
    <p:sldId id="270" r:id="rId15"/>
    <p:sldId id="271" r:id="rId16"/>
    <p:sldId id="272" r:id="rId17"/>
    <p:sldId id="273" r:id="rId18"/>
    <p:sldId id="274" r:id="rId1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1" autoAdjust="0"/>
    <p:restoredTop sz="94660"/>
  </p:normalViewPr>
  <p:slideViewPr>
    <p:cSldViewPr snapToGrid="0">
      <p:cViewPr>
        <p:scale>
          <a:sx n="120" d="100"/>
          <a:sy n="120" d="100"/>
        </p:scale>
        <p:origin x="520" y="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ED3905-A3D5-E15B-00C2-B3390EB35AC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7F444AC-F2C0-2E9D-A458-F7464E3D9C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B35C67-FE11-950B-7F0A-2E4BA4276F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E16D8-9735-4241-B589-89465389DCDA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DBA3AE-333F-E703-FCAB-D1274E745B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31251E-6B42-36C4-82A0-B4D6FB9BD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C8C3E-BCC8-4084-B624-346C06D72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449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E25B93-7148-45BD-6532-B1A0082657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6D76D6-41C9-1474-D401-C4F0AE9AA7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7DFC10-BC52-0C7A-377F-02F280CCF9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E16D8-9735-4241-B589-89465389DCDA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AFA68C-6750-A3C8-F500-A2AE61CB7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E0BB07-D53F-4FDF-B59E-2153C74225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C8C3E-BCC8-4084-B624-346C06D72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9305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FEB7F65-4684-01A4-696C-3E2B3DE924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53F4BC-89B6-1A44-A5A3-956C20DDDB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A269E9-D944-F97A-7560-CD1C053610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E16D8-9735-4241-B589-89465389DCDA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8F460C-03E1-E039-E5B6-0FCEED7D36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D48499-0803-4B52-889C-824F76FD6D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C8C3E-BCC8-4084-B624-346C06D72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945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8D0E22-2CE7-80A9-CE7D-97C22CF7A3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9BEC2A-4106-E93C-42F9-4E6BC71F6C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951D4B-9AFE-1897-95B6-CACB34740A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E16D8-9735-4241-B589-89465389DCDA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88366C-A07C-913E-37B5-66248A4FB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3B7139-AD69-511B-F0AD-604F0F8525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C8C3E-BCC8-4084-B624-346C06D72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7370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0B0638-4880-0B9A-F8DB-454BE3A971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18ABDE-B25C-4EF5-FFB8-D1A42206F9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299850-1C05-EE72-A2F8-29B99BCB7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E16D8-9735-4241-B589-89465389DCDA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C29A88-0F65-2590-C7DD-EC6AE57D2D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FAD265-94A8-DA60-978F-16F1EA713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C8C3E-BCC8-4084-B624-346C06D72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140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18F60D-167D-7DC8-CEB2-C7712DA404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F4E16C-5DF6-8DE8-8D4A-14024F85D3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17DC95-57EA-57FD-5A37-262F643560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8EF7A4-6A82-EB4A-49B9-E4540918A0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E16D8-9735-4241-B589-89465389DCDA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C7A92C-0742-B9FE-EA7B-46F3982D41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76A524-A475-9F92-D771-2963FE0946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C8C3E-BCC8-4084-B624-346C06D72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8824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519368-034F-D668-C8A3-6B48D733FE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C8B2DB-8C77-9682-7713-44A980CAAD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0AED07-1976-C436-1429-D49FFA9B1A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CF8C44A-9E09-1EC5-8646-8FABEA92E2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7FC9630-CB57-EA01-1DF5-3C10D795973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77F4027-BE05-69A8-6F82-BF5A0F18D2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E16D8-9735-4241-B589-89465389DCDA}" type="datetimeFigureOut">
              <a:rPr lang="en-US" smtClean="0"/>
              <a:t>5/2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0314AE5-C086-BF2C-C9F8-304110D048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9B0A2EB-6930-5618-5909-F08F0E4606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C8C3E-BCC8-4084-B624-346C06D72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68677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55D733-802D-1D30-2221-DF398F7180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12EDAC2-6050-D013-36D7-00A6384F39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E16D8-9735-4241-B589-89465389DCDA}" type="datetimeFigureOut">
              <a:rPr lang="en-US" smtClean="0"/>
              <a:t>5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1F6A39F-54BB-4508-6AA9-31C31B7DEA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DEB5956-917A-A0F4-D019-D637E1167F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C8C3E-BCC8-4084-B624-346C06D72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491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F9B6E74-C2CC-E344-8AA4-ADCEC004AF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E16D8-9735-4241-B589-89465389DCDA}" type="datetimeFigureOut">
              <a:rPr lang="en-US" smtClean="0"/>
              <a:t>5/2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47A01DB-AADD-6A4B-B5CE-2B0A3E843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72201EA-028A-D14B-E671-3773667A2E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C8C3E-BCC8-4084-B624-346C06D72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733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C996C9-E313-8C4D-F68F-12A1E8A86A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322CF8-D851-F817-ABDD-5D93D36E29D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2861D0A-FD27-C776-325A-9585FB1096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A104EC-A068-F224-D243-36219BC0E1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E16D8-9735-4241-B589-89465389DCDA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D242D8-42C6-0C5B-ABFF-2AA9276EDF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F1A15E-A3F4-302D-4108-EC080D8AB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C8C3E-BCC8-4084-B624-346C06D72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0569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922C23-8C92-AF84-9DFF-AF60E70C34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05ECD0B-4C16-5E4A-C572-026092B227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33F41EA-98E4-EEDE-F212-E9E6FD4637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0217EE-DAE8-4D06-E305-BC13B33AAF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E16D8-9735-4241-B589-89465389DCDA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07609B-78F6-0F4E-1571-6E7254F674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B0A687-C461-CCD1-206F-973111CF4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C8C3E-BCC8-4084-B624-346C06D72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678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6D960AA-F455-AD97-7B5C-B234FF92AF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7C0D36-69B0-8BA6-87BC-B3A58ED6D8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6787FE-D082-7E9C-5444-6760F1ECB76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9E16D8-9735-4241-B589-89465389DCDA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C96BA2-3D47-FC57-E4B0-B2C8E44AB1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AC9F25-7762-A243-0ABD-CA9D1EF28EC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FC8C3E-BCC8-4084-B624-346C06D723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897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37.png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emf"/><Relationship Id="rId2" Type="http://schemas.openxmlformats.org/officeDocument/2006/relationships/oleObject" Target="../embeddings/oleObject10.bin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1.png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emf"/><Relationship Id="rId2" Type="http://schemas.openxmlformats.org/officeDocument/2006/relationships/oleObject" Target="../embeddings/oleObject11.bin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5.png"/><Relationship Id="rId5" Type="http://schemas.openxmlformats.org/officeDocument/2006/relationships/image" Target="../media/image44.png"/><Relationship Id="rId4" Type="http://schemas.openxmlformats.org/officeDocument/2006/relationships/image" Target="../media/image43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9.png"/><Relationship Id="rId4" Type="http://schemas.openxmlformats.org/officeDocument/2006/relationships/image" Target="../media/image48.em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image" Target="../media/image50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3.png"/><Relationship Id="rId4" Type="http://schemas.openxmlformats.org/officeDocument/2006/relationships/image" Target="../media/image52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png"/><Relationship Id="rId2" Type="http://schemas.openxmlformats.org/officeDocument/2006/relationships/image" Target="../media/image54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7.png"/><Relationship Id="rId4" Type="http://schemas.openxmlformats.org/officeDocument/2006/relationships/image" Target="../media/image56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png"/><Relationship Id="rId2" Type="http://schemas.openxmlformats.org/officeDocument/2006/relationships/image" Target="../media/image58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1.png"/><Relationship Id="rId4" Type="http://schemas.openxmlformats.org/officeDocument/2006/relationships/image" Target="../media/image60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png"/><Relationship Id="rId2" Type="http://schemas.openxmlformats.org/officeDocument/2006/relationships/image" Target="../media/image62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5.png"/><Relationship Id="rId4" Type="http://schemas.openxmlformats.org/officeDocument/2006/relationships/image" Target="../media/image64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png"/><Relationship Id="rId2" Type="http://schemas.openxmlformats.org/officeDocument/2006/relationships/image" Target="../media/image66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9.png"/><Relationship Id="rId4" Type="http://schemas.openxmlformats.org/officeDocument/2006/relationships/image" Target="../media/image6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png"/><Relationship Id="rId5" Type="http://schemas.openxmlformats.org/officeDocument/2006/relationships/image" Target="../media/image3.emf"/><Relationship Id="rId4" Type="http://schemas.openxmlformats.org/officeDocument/2006/relationships/oleObject" Target="../embeddings/oleObject1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7" Type="http://schemas.openxmlformats.org/officeDocument/2006/relationships/image" Target="../media/image25.png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oleObject" Target="../embeddings/oleObject8.bin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33.png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883235-57D7-CAF6-308A-B37EFA6BA61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Western Blots of Human Heart Tissues 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5FB2BDD-C5BB-56B0-283B-9565F08785A2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97460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DDD434-E1BF-C793-1ECE-C09DE3743C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PP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3863ADA-81F0-F047-D4B5-904E24A8578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1548972"/>
              </p:ext>
            </p:extLst>
          </p:nvPr>
        </p:nvGraphicFramePr>
        <p:xfrm>
          <a:off x="4738056" y="2621874"/>
          <a:ext cx="2179637" cy="2465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180262" imgH="2465254" progId="Prism10.Document">
                  <p:embed/>
                </p:oleObj>
              </mc:Choice>
              <mc:Fallback>
                <p:oleObj name="Prism 10" r:id="rId2" imgW="2180262" imgH="246525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738056" y="2621874"/>
                        <a:ext cx="2179637" cy="2465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E50FA80D-B6D2-0103-F52E-C65666EF4FC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25028" y="1516441"/>
            <a:ext cx="2783463" cy="200335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BD20158-910D-E759-59BF-7731B8922E9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22846" y="1306849"/>
            <a:ext cx="1905266" cy="45726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F4FEE09-5D4A-8F66-E0BD-7AED3D3BF9F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22846" y="1742341"/>
            <a:ext cx="2010056" cy="8383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433127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CBEB75-A0C1-26F1-6502-ED8DF3E55A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MOX1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9599B63-56DF-CD5C-DF38-94A8A5EFC5A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3528943"/>
              </p:ext>
            </p:extLst>
          </p:nvPr>
        </p:nvGraphicFramePr>
        <p:xfrm>
          <a:off x="5003800" y="2181225"/>
          <a:ext cx="2182813" cy="2492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183143" imgH="2492986" progId="Prism10.Document">
                  <p:embed/>
                </p:oleObj>
              </mc:Choice>
              <mc:Fallback>
                <p:oleObj name="Prism 10" r:id="rId2" imgW="2183143" imgH="2492986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003800" y="2181225"/>
                        <a:ext cx="2182813" cy="2492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2B7B0D42-BBFF-26CC-D017-B62A6B53539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6847" y="1411215"/>
            <a:ext cx="3046125" cy="196401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2EBDD98-2EDD-F637-2579-910CFD5C475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57524" y="772239"/>
            <a:ext cx="2886478" cy="45726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880718E-273C-A47B-26BD-4CF83E158DC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47998" y="1243208"/>
            <a:ext cx="2896004" cy="9145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99687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E08DF61-1A68-0704-FAA4-4C5D79F2F0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8591057"/>
              </p:ext>
            </p:extLst>
          </p:nvPr>
        </p:nvGraphicFramePr>
        <p:xfrm>
          <a:off x="5841850" y="2669096"/>
          <a:ext cx="2303463" cy="2452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303788" imgH="2453009" progId="Prism10.Document">
                  <p:embed/>
                </p:oleObj>
              </mc:Choice>
              <mc:Fallback>
                <p:oleObj name="Prism 10" r:id="rId2" imgW="2303788" imgH="245300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841850" y="2669096"/>
                        <a:ext cx="2303463" cy="2452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03545B2D-36C0-5A8A-792E-D4504A97B8D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3203" y="1690687"/>
            <a:ext cx="4294931" cy="301228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9DED15A-D22B-0EC9-EFB3-9D232CBFA7B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36054" y="1271874"/>
            <a:ext cx="2915057" cy="50489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9BA6D7F-FC16-943B-F72B-CF992265D0D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17002" y="1830779"/>
            <a:ext cx="2934109" cy="838317"/>
          </a:xfrm>
          <a:prstGeom prst="rect">
            <a:avLst/>
          </a:prstGeom>
        </p:spPr>
      </p:pic>
      <p:sp>
        <p:nvSpPr>
          <p:cNvPr id="6" name="Title 5">
            <a:extLst>
              <a:ext uri="{FF2B5EF4-FFF2-40B4-BE49-F238E27FC236}">
                <a16:creationId xmlns:a16="http://schemas.microsoft.com/office/drawing/2014/main" id="{00AB4960-E2B3-21AE-4801-E4794B2B6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FR</a:t>
            </a:r>
          </a:p>
        </p:txBody>
      </p:sp>
    </p:spTree>
    <p:extLst>
      <p:ext uri="{BB962C8B-B14F-4D97-AF65-F5344CB8AC3E}">
        <p14:creationId xmlns:p14="http://schemas.microsoft.com/office/powerpoint/2010/main" val="363919884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0D24FD6-11A7-235E-76B5-D46A483F1E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08769" y="722367"/>
            <a:ext cx="1727200" cy="8128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3C36FA6-8BA2-2772-5460-B104A37961F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335"/>
          <a:stretch/>
        </p:blipFill>
        <p:spPr>
          <a:xfrm>
            <a:off x="6708768" y="1669874"/>
            <a:ext cx="1727201" cy="162441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97942B4-F9FE-5A1E-D341-15B9E9278C8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08767" y="3429000"/>
            <a:ext cx="2146300" cy="2387600"/>
          </a:xfrm>
          <a:prstGeom prst="rect">
            <a:avLst/>
          </a:prstGeom>
        </p:spPr>
      </p:pic>
      <p:grpSp>
        <p:nvGrpSpPr>
          <p:cNvPr id="12" name="Group 11">
            <a:extLst>
              <a:ext uri="{FF2B5EF4-FFF2-40B4-BE49-F238E27FC236}">
                <a16:creationId xmlns:a16="http://schemas.microsoft.com/office/drawing/2014/main" id="{C632FB4E-87F1-0E47-806D-8E086C763995}"/>
              </a:ext>
            </a:extLst>
          </p:cNvPr>
          <p:cNvGrpSpPr/>
          <p:nvPr/>
        </p:nvGrpSpPr>
        <p:grpSpPr>
          <a:xfrm>
            <a:off x="212603" y="878450"/>
            <a:ext cx="5096108" cy="3394961"/>
            <a:chOff x="-1" y="3463039"/>
            <a:chExt cx="5096108" cy="3394961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F6D7157B-6A41-9E46-16AD-880793C5988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-1" y="3463039"/>
              <a:ext cx="5096108" cy="3394961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79FA94A-9F3A-0D69-01BB-8DA7E2C3C9EE}"/>
                </a:ext>
              </a:extLst>
            </p:cNvPr>
            <p:cNvSpPr txBox="1"/>
            <p:nvPr/>
          </p:nvSpPr>
          <p:spPr>
            <a:xfrm>
              <a:off x="635620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9BF9406-50CB-B0A6-E5ED-E60695E5E43E}"/>
                </a:ext>
              </a:extLst>
            </p:cNvPr>
            <p:cNvSpPr txBox="1"/>
            <p:nvPr/>
          </p:nvSpPr>
          <p:spPr>
            <a:xfrm>
              <a:off x="1548434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8A007EF-9A9C-DE90-C19C-E48D33486FC4}"/>
                </a:ext>
              </a:extLst>
            </p:cNvPr>
            <p:cNvSpPr txBox="1"/>
            <p:nvPr/>
          </p:nvSpPr>
          <p:spPr>
            <a:xfrm>
              <a:off x="2409456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FCF27E0-2106-6582-618D-6C4BE1B9AE72}"/>
                </a:ext>
              </a:extLst>
            </p:cNvPr>
            <p:cNvSpPr txBox="1"/>
            <p:nvPr/>
          </p:nvSpPr>
          <p:spPr>
            <a:xfrm>
              <a:off x="3305990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15C92067-9E49-2C2A-AD0D-8D1C9791A392}"/>
              </a:ext>
            </a:extLst>
          </p:cNvPr>
          <p:cNvSpPr txBox="1"/>
          <p:nvPr/>
        </p:nvSpPr>
        <p:spPr>
          <a:xfrm>
            <a:off x="6047748" y="981169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4HN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C609509-854B-1E6A-4D99-836C3D6F6E44}"/>
              </a:ext>
            </a:extLst>
          </p:cNvPr>
          <p:cNvSpPr txBox="1"/>
          <p:nvPr/>
        </p:nvSpPr>
        <p:spPr>
          <a:xfrm>
            <a:off x="5831464" y="1904499"/>
            <a:ext cx="9924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Total Protein</a:t>
            </a:r>
          </a:p>
        </p:txBody>
      </p:sp>
    </p:spTree>
    <p:extLst>
      <p:ext uri="{BB962C8B-B14F-4D97-AF65-F5344CB8AC3E}">
        <p14:creationId xmlns:p14="http://schemas.microsoft.com/office/powerpoint/2010/main" val="68062169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27567A2-D81F-A8D3-0D82-F07AB466F8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18402" y="2792549"/>
            <a:ext cx="2032000" cy="23749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92B5865-C1D4-E15C-8EC6-0928046188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53354" y="664280"/>
            <a:ext cx="1562100" cy="4572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08C8614-9515-02EA-2D52-69C893318ED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53353" y="1121480"/>
            <a:ext cx="1562099" cy="1471978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A19082A7-BB9D-3EFA-7495-5606C6AA18F7}"/>
              </a:ext>
            </a:extLst>
          </p:cNvPr>
          <p:cNvGrpSpPr/>
          <p:nvPr/>
        </p:nvGrpSpPr>
        <p:grpSpPr>
          <a:xfrm>
            <a:off x="369589" y="692778"/>
            <a:ext cx="4847985" cy="3164857"/>
            <a:chOff x="135673" y="3546088"/>
            <a:chExt cx="4847985" cy="3164857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BF876C17-97BA-C9C0-6132-5E3E1BA6A99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35673" y="3546088"/>
              <a:ext cx="4847985" cy="3164857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6593E9A-462E-265A-18CD-1382CCB8B9C0}"/>
                </a:ext>
              </a:extLst>
            </p:cNvPr>
            <p:cNvSpPr txBox="1"/>
            <p:nvPr/>
          </p:nvSpPr>
          <p:spPr>
            <a:xfrm>
              <a:off x="814039" y="3974790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8C70A23-0B12-8A8A-3249-5BB98D3C0815}"/>
                </a:ext>
              </a:extLst>
            </p:cNvPr>
            <p:cNvSpPr txBox="1"/>
            <p:nvPr/>
          </p:nvSpPr>
          <p:spPr>
            <a:xfrm>
              <a:off x="1726853" y="3974790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CAE5863-91DF-37C6-AC8E-19FFF0840D91}"/>
                </a:ext>
              </a:extLst>
            </p:cNvPr>
            <p:cNvSpPr txBox="1"/>
            <p:nvPr/>
          </p:nvSpPr>
          <p:spPr>
            <a:xfrm>
              <a:off x="2587875" y="3974790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83615EF-7D92-107D-45FE-A7509A8A757D}"/>
                </a:ext>
              </a:extLst>
            </p:cNvPr>
            <p:cNvSpPr txBox="1"/>
            <p:nvPr/>
          </p:nvSpPr>
          <p:spPr>
            <a:xfrm>
              <a:off x="3484409" y="3974790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72FC81AE-66AA-B331-096F-2E940D2DDB5D}"/>
              </a:ext>
            </a:extLst>
          </p:cNvPr>
          <p:cNvSpPr txBox="1"/>
          <p:nvPr/>
        </p:nvSpPr>
        <p:spPr>
          <a:xfrm>
            <a:off x="5631167" y="721490"/>
            <a:ext cx="1271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aspase 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0420DFF-6690-1AB2-2FB5-F3C1D9F23EA2}"/>
              </a:ext>
            </a:extLst>
          </p:cNvPr>
          <p:cNvSpPr txBox="1"/>
          <p:nvPr/>
        </p:nvSpPr>
        <p:spPr>
          <a:xfrm>
            <a:off x="5848068" y="1690551"/>
            <a:ext cx="9924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Total Protein</a:t>
            </a:r>
          </a:p>
        </p:txBody>
      </p:sp>
    </p:spTree>
    <p:extLst>
      <p:ext uri="{BB962C8B-B14F-4D97-AF65-F5344CB8AC3E}">
        <p14:creationId xmlns:p14="http://schemas.microsoft.com/office/powerpoint/2010/main" val="186076780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2F05B49-BFC2-A5A8-B18F-A3811838DF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40333" y="3278855"/>
            <a:ext cx="2095500" cy="22606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B9637D2-D788-CFB0-C4CF-F6B70D78D9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80188" y="152797"/>
            <a:ext cx="1727200" cy="11938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0C4B3A5-ECBC-1641-DAE4-4A5813A49A3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80188" y="1312523"/>
            <a:ext cx="1727200" cy="1676893"/>
          </a:xfrm>
          <a:prstGeom prst="rect">
            <a:avLst/>
          </a:prstGeom>
        </p:spPr>
      </p:pic>
      <p:grpSp>
        <p:nvGrpSpPr>
          <p:cNvPr id="12" name="Group 11">
            <a:extLst>
              <a:ext uri="{FF2B5EF4-FFF2-40B4-BE49-F238E27FC236}">
                <a16:creationId xmlns:a16="http://schemas.microsoft.com/office/drawing/2014/main" id="{3FCD9F47-B583-DB64-3E02-2F19925EE6B0}"/>
              </a:ext>
            </a:extLst>
          </p:cNvPr>
          <p:cNvGrpSpPr/>
          <p:nvPr/>
        </p:nvGrpSpPr>
        <p:grpSpPr>
          <a:xfrm>
            <a:off x="489097" y="287377"/>
            <a:ext cx="4962293" cy="3284187"/>
            <a:chOff x="0" y="3463942"/>
            <a:chExt cx="4962293" cy="3284187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EA6E14D6-3EAB-B274-9EB2-DEABEC0E6EE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0" y="3463942"/>
              <a:ext cx="4962293" cy="3284187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F651D0E-7837-243F-C509-8A717E6C942D}"/>
                </a:ext>
              </a:extLst>
            </p:cNvPr>
            <p:cNvSpPr txBox="1"/>
            <p:nvPr/>
          </p:nvSpPr>
          <p:spPr>
            <a:xfrm>
              <a:off x="635620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B55EA41-0C51-CFC3-5B00-6E0D2BCB1DFA}"/>
                </a:ext>
              </a:extLst>
            </p:cNvPr>
            <p:cNvSpPr txBox="1"/>
            <p:nvPr/>
          </p:nvSpPr>
          <p:spPr>
            <a:xfrm>
              <a:off x="1548434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70E851A-F983-602A-8524-9D85A45FCE0A}"/>
                </a:ext>
              </a:extLst>
            </p:cNvPr>
            <p:cNvSpPr txBox="1"/>
            <p:nvPr/>
          </p:nvSpPr>
          <p:spPr>
            <a:xfrm>
              <a:off x="2409456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B4F2621-B6BA-A45F-5074-95E379BFD49C}"/>
                </a:ext>
              </a:extLst>
            </p:cNvPr>
            <p:cNvSpPr txBox="1"/>
            <p:nvPr/>
          </p:nvSpPr>
          <p:spPr>
            <a:xfrm>
              <a:off x="3305990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055C738D-8CB9-7DC2-F591-76B81DB98548}"/>
              </a:ext>
            </a:extLst>
          </p:cNvPr>
          <p:cNvSpPr txBox="1"/>
          <p:nvPr/>
        </p:nvSpPr>
        <p:spPr>
          <a:xfrm>
            <a:off x="5735381" y="544983"/>
            <a:ext cx="1271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aspase 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B03DAB9-0BD1-4DD8-8FAA-DEE5DDD41B6D}"/>
              </a:ext>
            </a:extLst>
          </p:cNvPr>
          <p:cNvSpPr txBox="1"/>
          <p:nvPr/>
        </p:nvSpPr>
        <p:spPr>
          <a:xfrm>
            <a:off x="5887729" y="1666395"/>
            <a:ext cx="9924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Total Protein</a:t>
            </a:r>
          </a:p>
        </p:txBody>
      </p:sp>
    </p:spTree>
    <p:extLst>
      <p:ext uri="{BB962C8B-B14F-4D97-AF65-F5344CB8AC3E}">
        <p14:creationId xmlns:p14="http://schemas.microsoft.com/office/powerpoint/2010/main" val="396134036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8CE68C0-0FF9-507F-CF01-A57F261B34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85940" y="3213666"/>
            <a:ext cx="2019300" cy="24130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80C0E89-05D0-23E4-4D23-8A039177647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85940" y="389155"/>
            <a:ext cx="1676400" cy="8763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ED30EF5-76C7-2BE1-D8B0-CF28C75D559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85940" y="1376967"/>
            <a:ext cx="1676399" cy="1521177"/>
          </a:xfrm>
          <a:prstGeom prst="rect">
            <a:avLst/>
          </a:prstGeom>
        </p:spPr>
      </p:pic>
      <p:grpSp>
        <p:nvGrpSpPr>
          <p:cNvPr id="12" name="Group 11">
            <a:extLst>
              <a:ext uri="{FF2B5EF4-FFF2-40B4-BE49-F238E27FC236}">
                <a16:creationId xmlns:a16="http://schemas.microsoft.com/office/drawing/2014/main" id="{3732A6AE-E08C-1189-F462-4E1ABEC07F4E}"/>
              </a:ext>
            </a:extLst>
          </p:cNvPr>
          <p:cNvGrpSpPr/>
          <p:nvPr/>
        </p:nvGrpSpPr>
        <p:grpSpPr>
          <a:xfrm>
            <a:off x="350875" y="389155"/>
            <a:ext cx="4493789" cy="3256155"/>
            <a:chOff x="1" y="3601844"/>
            <a:chExt cx="4493789" cy="3256155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1410FF82-CB96-37A0-694A-79609E8BBC9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" y="3601844"/>
              <a:ext cx="4493789" cy="3256155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9345D2F-378F-A1E9-E6F5-899B2969242F}"/>
                </a:ext>
              </a:extLst>
            </p:cNvPr>
            <p:cNvSpPr txBox="1"/>
            <p:nvPr/>
          </p:nvSpPr>
          <p:spPr>
            <a:xfrm>
              <a:off x="635620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B841B3E-7D1E-E30D-D307-3B3179E5EA3D}"/>
                </a:ext>
              </a:extLst>
            </p:cNvPr>
            <p:cNvSpPr txBox="1"/>
            <p:nvPr/>
          </p:nvSpPr>
          <p:spPr>
            <a:xfrm>
              <a:off x="1548434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59A3101-ACC7-A962-FD96-96E4A2FCEBFE}"/>
                </a:ext>
              </a:extLst>
            </p:cNvPr>
            <p:cNvSpPr txBox="1"/>
            <p:nvPr/>
          </p:nvSpPr>
          <p:spPr>
            <a:xfrm>
              <a:off x="2409456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8468C96-41AA-50FB-AC94-824FA5070633}"/>
                </a:ext>
              </a:extLst>
            </p:cNvPr>
            <p:cNvSpPr txBox="1"/>
            <p:nvPr/>
          </p:nvSpPr>
          <p:spPr>
            <a:xfrm>
              <a:off x="3305990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FCD97873-2BB7-CD4F-EA17-65F0A69E30E3}"/>
              </a:ext>
            </a:extLst>
          </p:cNvPr>
          <p:cNvSpPr txBox="1"/>
          <p:nvPr/>
        </p:nvSpPr>
        <p:spPr>
          <a:xfrm>
            <a:off x="5414420" y="616000"/>
            <a:ext cx="1271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aspase 8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021B06D-7024-DB52-C6C9-18E9D08DB27C}"/>
              </a:ext>
            </a:extLst>
          </p:cNvPr>
          <p:cNvSpPr txBox="1"/>
          <p:nvPr/>
        </p:nvSpPr>
        <p:spPr>
          <a:xfrm>
            <a:off x="5593481" y="1580977"/>
            <a:ext cx="9924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Total Protein</a:t>
            </a:r>
          </a:p>
        </p:txBody>
      </p:sp>
    </p:spTree>
    <p:extLst>
      <p:ext uri="{BB962C8B-B14F-4D97-AF65-F5344CB8AC3E}">
        <p14:creationId xmlns:p14="http://schemas.microsoft.com/office/powerpoint/2010/main" val="203894896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26B0D4C-39C8-788C-391A-0FB5AFD119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49773" y="3196422"/>
            <a:ext cx="2095500" cy="23622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9F74AD6-5AEC-990A-CD49-BFA5D6ED401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6627470" y="447481"/>
            <a:ext cx="1731296" cy="85272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CFDE68B-E55A-7B4E-08FF-27CE7B5FDC2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flipH="1">
            <a:off x="6627470" y="1299378"/>
            <a:ext cx="1731296" cy="1662044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218FE221-773C-550B-5ABD-54F4E8DFE4E8}"/>
              </a:ext>
            </a:extLst>
          </p:cNvPr>
          <p:cNvGrpSpPr/>
          <p:nvPr/>
        </p:nvGrpSpPr>
        <p:grpSpPr>
          <a:xfrm>
            <a:off x="212652" y="447481"/>
            <a:ext cx="5096107" cy="3544478"/>
            <a:chOff x="0" y="3211946"/>
            <a:chExt cx="5096107" cy="3544478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B51D3F55-64EE-B2DD-4D09-826F9402BC4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0" y="3211946"/>
              <a:ext cx="5096107" cy="3544478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64D4FFF-A4F1-B136-45E4-5E6789BE12A6}"/>
                </a:ext>
              </a:extLst>
            </p:cNvPr>
            <p:cNvSpPr txBox="1"/>
            <p:nvPr/>
          </p:nvSpPr>
          <p:spPr>
            <a:xfrm>
              <a:off x="635620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396F651-21C6-222E-FDE7-CD8162B2EB15}"/>
                </a:ext>
              </a:extLst>
            </p:cNvPr>
            <p:cNvSpPr txBox="1"/>
            <p:nvPr/>
          </p:nvSpPr>
          <p:spPr>
            <a:xfrm>
              <a:off x="1548434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996A56D-FA40-41AE-C20D-23F4655A7783}"/>
                </a:ext>
              </a:extLst>
            </p:cNvPr>
            <p:cNvSpPr txBox="1"/>
            <p:nvPr/>
          </p:nvSpPr>
          <p:spPr>
            <a:xfrm>
              <a:off x="2409456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5E9E347-A3BA-4325-8FC3-30CBC8252E25}"/>
                </a:ext>
              </a:extLst>
            </p:cNvPr>
            <p:cNvSpPr txBox="1"/>
            <p:nvPr/>
          </p:nvSpPr>
          <p:spPr>
            <a:xfrm>
              <a:off x="3305990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3031E522-8227-B385-E467-14127AFD5DFD}"/>
              </a:ext>
            </a:extLst>
          </p:cNvPr>
          <p:cNvSpPr txBox="1"/>
          <p:nvPr/>
        </p:nvSpPr>
        <p:spPr>
          <a:xfrm>
            <a:off x="5623669" y="658683"/>
            <a:ext cx="10038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SDM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4270375-A8A6-D910-102B-4A42F1DFE52E}"/>
              </a:ext>
            </a:extLst>
          </p:cNvPr>
          <p:cNvSpPr txBox="1"/>
          <p:nvPr/>
        </p:nvSpPr>
        <p:spPr>
          <a:xfrm>
            <a:off x="5635011" y="1576661"/>
            <a:ext cx="9924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Total Protein</a:t>
            </a:r>
          </a:p>
        </p:txBody>
      </p:sp>
    </p:spTree>
    <p:extLst>
      <p:ext uri="{BB962C8B-B14F-4D97-AF65-F5344CB8AC3E}">
        <p14:creationId xmlns:p14="http://schemas.microsoft.com/office/powerpoint/2010/main" val="1613620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AE9BDB3-39D4-1E93-BE9B-ACBC85A737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0" y="2888838"/>
            <a:ext cx="2019300" cy="25146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7191F7EF-600F-195C-45F6-F56B20C794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04861" y="353827"/>
            <a:ext cx="1663700" cy="762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3D39D64-FDDA-4A18-CAB0-B2F1BABAB7C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04861" y="1115827"/>
            <a:ext cx="1753886" cy="1596036"/>
          </a:xfrm>
          <a:prstGeom prst="rect">
            <a:avLst/>
          </a:prstGeom>
        </p:spPr>
      </p:pic>
      <p:grpSp>
        <p:nvGrpSpPr>
          <p:cNvPr id="12" name="Group 11">
            <a:extLst>
              <a:ext uri="{FF2B5EF4-FFF2-40B4-BE49-F238E27FC236}">
                <a16:creationId xmlns:a16="http://schemas.microsoft.com/office/drawing/2014/main" id="{EC350816-3EBE-D7BA-97CA-AA70DEA31D43}"/>
              </a:ext>
            </a:extLst>
          </p:cNvPr>
          <p:cNvGrpSpPr/>
          <p:nvPr/>
        </p:nvGrpSpPr>
        <p:grpSpPr>
          <a:xfrm>
            <a:off x="148856" y="353827"/>
            <a:ext cx="4871154" cy="3289610"/>
            <a:chOff x="0" y="3568390"/>
            <a:chExt cx="4871154" cy="328961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43D1E108-08C1-D20C-3EBA-D989ED91026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0" y="3568390"/>
              <a:ext cx="4871154" cy="328961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AEF7356-4C1D-382F-70A7-B86794ACF953}"/>
                </a:ext>
              </a:extLst>
            </p:cNvPr>
            <p:cNvSpPr txBox="1"/>
            <p:nvPr/>
          </p:nvSpPr>
          <p:spPr>
            <a:xfrm>
              <a:off x="635620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FDDB6FA-64DF-0001-59A5-E094E4C15E17}"/>
                </a:ext>
              </a:extLst>
            </p:cNvPr>
            <p:cNvSpPr txBox="1"/>
            <p:nvPr/>
          </p:nvSpPr>
          <p:spPr>
            <a:xfrm>
              <a:off x="1548434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0B37197-D9D8-24C2-0FE7-05FED3AE3B1D}"/>
                </a:ext>
              </a:extLst>
            </p:cNvPr>
            <p:cNvSpPr txBox="1"/>
            <p:nvPr/>
          </p:nvSpPr>
          <p:spPr>
            <a:xfrm>
              <a:off x="2409456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8F552CC-229D-B295-7D2B-D315DFCF9C3F}"/>
                </a:ext>
              </a:extLst>
            </p:cNvPr>
            <p:cNvSpPr txBox="1"/>
            <p:nvPr/>
          </p:nvSpPr>
          <p:spPr>
            <a:xfrm>
              <a:off x="3305990" y="4119756"/>
              <a:ext cx="912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T </a:t>
              </a:r>
              <a:r>
                <a:rPr lang="en-US" dirty="0" err="1"/>
                <a:t>dHF</a:t>
              </a:r>
              <a:endParaRPr lang="en-US" dirty="0"/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12D1C8A2-3602-D1F0-37E4-23EDBCDBA7E6}"/>
              </a:ext>
            </a:extLst>
          </p:cNvPr>
          <p:cNvSpPr txBox="1"/>
          <p:nvPr/>
        </p:nvSpPr>
        <p:spPr>
          <a:xfrm>
            <a:off x="5359340" y="589095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MLK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59D71C5-A94E-64E9-5B10-0A281171A959}"/>
              </a:ext>
            </a:extLst>
          </p:cNvPr>
          <p:cNvSpPr txBox="1"/>
          <p:nvPr/>
        </p:nvSpPr>
        <p:spPr>
          <a:xfrm>
            <a:off x="5212402" y="1590679"/>
            <a:ext cx="9924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Total Protein</a:t>
            </a:r>
          </a:p>
        </p:txBody>
      </p:sp>
    </p:spTree>
    <p:extLst>
      <p:ext uri="{BB962C8B-B14F-4D97-AF65-F5344CB8AC3E}">
        <p14:creationId xmlns:p14="http://schemas.microsoft.com/office/powerpoint/2010/main" val="34311333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8B11A9-578C-EF72-531F-F43704AAB9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865243" cy="1325563"/>
          </a:xfrm>
        </p:spPr>
        <p:txBody>
          <a:bodyPr/>
          <a:lstStyle/>
          <a:p>
            <a:r>
              <a:rPr lang="en-US" dirty="0"/>
              <a:t>GSR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CF90393-7A2B-941D-665F-C6AE1A08F3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90738" y="1149481"/>
            <a:ext cx="2019582" cy="34294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8C14A72-89F0-7913-3176-716315152A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90738" y="1492428"/>
            <a:ext cx="2019582" cy="844005"/>
          </a:xfrm>
          <a:prstGeom prst="rect">
            <a:avLst/>
          </a:prstGeom>
        </p:spPr>
      </p:pic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E2123298-BD35-12E1-ADC4-CA59EEA651B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2138041"/>
              </p:ext>
            </p:extLst>
          </p:nvPr>
        </p:nvGraphicFramePr>
        <p:xfrm>
          <a:off x="5590738" y="2601410"/>
          <a:ext cx="2187575" cy="2452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2187824" imgH="2453009" progId="Prism10.Document">
                  <p:embed/>
                </p:oleObj>
              </mc:Choice>
              <mc:Fallback>
                <p:oleObj name="Prism 10" r:id="rId4" imgW="2187824" imgH="245300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590738" y="2601410"/>
                        <a:ext cx="2187575" cy="2452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9" name="Picture 8">
            <a:extLst>
              <a:ext uri="{FF2B5EF4-FFF2-40B4-BE49-F238E27FC236}">
                <a16:creationId xmlns:a16="http://schemas.microsoft.com/office/drawing/2014/main" id="{7D300464-D652-3EBD-EA8F-D989C5BEB95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127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34876" y="1690688"/>
            <a:ext cx="4520153" cy="30873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52986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1A9075-C1A8-8C6C-640F-2A3FAC933E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MT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21CE385-6148-3E93-B6D8-04F5E0A8E4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83071" y="789046"/>
            <a:ext cx="3029373" cy="514422"/>
          </a:xfrm>
          <a:prstGeom prst="rect">
            <a:avLst/>
          </a:prstGeom>
        </p:spPr>
      </p:pic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70DF5618-AC6A-AFB5-0892-CEAF59BE70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9511287"/>
              </p:ext>
            </p:extLst>
          </p:nvPr>
        </p:nvGraphicFramePr>
        <p:xfrm>
          <a:off x="5106350" y="2592329"/>
          <a:ext cx="2182813" cy="2595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2183143" imgH="2594910" progId="Prism10.Document">
                  <p:embed/>
                </p:oleObj>
              </mc:Choice>
              <mc:Fallback>
                <p:oleObj name="Prism 10" r:id="rId3" imgW="2183143" imgH="2594910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106350" y="2592329"/>
                        <a:ext cx="2182813" cy="2595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" name="Picture 6">
            <a:extLst>
              <a:ext uri="{FF2B5EF4-FFF2-40B4-BE49-F238E27FC236}">
                <a16:creationId xmlns:a16="http://schemas.microsoft.com/office/drawing/2014/main" id="{85BCA2F3-1A91-69D0-4ADD-A997157F6EE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02124" y="1266766"/>
            <a:ext cx="3010320" cy="84784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23AF1DD-E574-554C-CD48-94884D6427D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4499" y="1433477"/>
            <a:ext cx="3661846" cy="24638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32962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9E54C8-77F8-C2E3-4716-7403AEB6D2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TF4</a:t>
            </a:r>
            <a:br>
              <a:rPr lang="en-US" dirty="0"/>
            </a:br>
            <a:endParaRPr lang="en-US" dirty="0"/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8FB5C4E-C429-2F3B-F317-C0A87CAB0DE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44344820"/>
              </p:ext>
            </p:extLst>
          </p:nvPr>
        </p:nvGraphicFramePr>
        <p:xfrm>
          <a:off x="4655200" y="2673352"/>
          <a:ext cx="2179637" cy="2570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180262" imgH="2570419" progId="Prism10.Document">
                  <p:embed/>
                </p:oleObj>
              </mc:Choice>
              <mc:Fallback>
                <p:oleObj name="Prism 10" r:id="rId2" imgW="2180262" imgH="257041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655200" y="2673352"/>
                        <a:ext cx="2179637" cy="2570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B2F8B48D-696E-2FA9-2F4E-A981369CE23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5988" y="1309391"/>
            <a:ext cx="3782007" cy="295780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9A59AEE-987A-64F4-FCC9-16CDE2C7234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48465" y="365125"/>
            <a:ext cx="4972744" cy="64779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4DFBDF7-7431-E0C0-BFC9-61D24272FDC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48465" y="891396"/>
            <a:ext cx="4972744" cy="13911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97868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256AF4-E387-FB01-39D9-53F26557D0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erroportin-1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1D98C20-60A4-C904-F876-4D9DC4EF101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13341139"/>
              </p:ext>
            </p:extLst>
          </p:nvPr>
        </p:nvGraphicFramePr>
        <p:xfrm>
          <a:off x="4993496" y="2447445"/>
          <a:ext cx="2179637" cy="2452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180262" imgH="2453009" progId="Prism10.Document">
                  <p:embed/>
                </p:oleObj>
              </mc:Choice>
              <mc:Fallback>
                <p:oleObj name="Prism 10" r:id="rId2" imgW="2180262" imgH="245300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993496" y="2447445"/>
                        <a:ext cx="2179637" cy="2452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C90C0066-75CE-319A-CD96-8E4BAD19256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8200" y="1533478"/>
            <a:ext cx="3473550" cy="235803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E07AB39-9574-EAB4-3B60-EDA8D017356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93827" y="679900"/>
            <a:ext cx="2686425" cy="36200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EE069C9-96CA-4352-9444-1EBF48FCCC4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93827" y="1041901"/>
            <a:ext cx="2638793" cy="8192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14920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837314-D25B-C8D0-7E91-FAA35B5D88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NRF2</a:t>
            </a:r>
            <a:br>
              <a:rPr lang="en-US" dirty="0"/>
            </a:br>
            <a:endParaRPr lang="en-US" dirty="0"/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37AC299-6595-A11B-8034-0605B9862B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1701070"/>
              </p:ext>
            </p:extLst>
          </p:nvPr>
        </p:nvGraphicFramePr>
        <p:xfrm>
          <a:off x="5247474" y="2033133"/>
          <a:ext cx="2190750" cy="2992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190706" imgH="2992880" progId="Prism10.Document">
                  <p:embed/>
                </p:oleObj>
              </mc:Choice>
              <mc:Fallback>
                <p:oleObj name="Prism 10" r:id="rId2" imgW="2190706" imgH="2992880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247474" y="2033133"/>
                        <a:ext cx="2190750" cy="2992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8ABE67F6-8548-DF58-8DD8-B83194175BA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5302" y="1027906"/>
            <a:ext cx="3816862" cy="224869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D11BAB4-2E1F-7A38-E147-FC60A3DCD74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61637" y="707570"/>
            <a:ext cx="1962424" cy="36200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4CFA79C-40D6-1F95-BF91-3B15F0593F7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61637" y="1062828"/>
            <a:ext cx="1886213" cy="8287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38189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8DCDB3-D143-8639-6933-31DE7A5C47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LC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60A92A1B-9198-20E4-DF6F-8E54408B18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3313699"/>
              </p:ext>
            </p:extLst>
          </p:nvPr>
        </p:nvGraphicFramePr>
        <p:xfrm>
          <a:off x="5315319" y="2727251"/>
          <a:ext cx="2178050" cy="2919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178461" imgH="2919769" progId="Prism10.Document">
                  <p:embed/>
                </p:oleObj>
              </mc:Choice>
              <mc:Fallback>
                <p:oleObj name="Prism 10" r:id="rId2" imgW="2178461" imgH="291976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315319" y="2727251"/>
                        <a:ext cx="2178050" cy="2919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E9BD5478-D52B-E4BB-3B9D-7C80510A6F3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4791" y="1283694"/>
            <a:ext cx="3485326" cy="243394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32232E4-3FE8-D9EA-A981-1DB77A2F611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71919" y="1211336"/>
            <a:ext cx="2029108" cy="371527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0D95FEE-DBFE-E476-F9A8-E80D9DF2D1A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71919" y="1606236"/>
            <a:ext cx="2048161" cy="95263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F6CA9971-7212-F2B1-E48B-0D9CD987E47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7880" y="4424054"/>
            <a:ext cx="3509030" cy="24339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40812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96AF0E-FD53-BB48-F0C8-8D26D91DF3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VDAC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CA79227-D39F-7AF5-967C-485EFC6FB62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4538217"/>
              </p:ext>
            </p:extLst>
          </p:nvPr>
        </p:nvGraphicFramePr>
        <p:xfrm>
          <a:off x="4753681" y="2677115"/>
          <a:ext cx="2182813" cy="2479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183143" imgH="2478940" progId="Prism10.Document">
                  <p:embed/>
                </p:oleObj>
              </mc:Choice>
              <mc:Fallback>
                <p:oleObj name="Prism 10" r:id="rId2" imgW="2183143" imgH="2478940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753681" y="2677115"/>
                        <a:ext cx="2182813" cy="2479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1BE0C723-C945-D75A-5D17-B1CE67A9E1B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6395" y="1608112"/>
            <a:ext cx="2633183" cy="177875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DE54F37-FEEA-6173-1AB4-1A6C3E77BB0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09835" y="1428783"/>
            <a:ext cx="2105319" cy="113607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6DFA869-887D-1D34-C709-C7AD4E9917E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09835" y="970159"/>
            <a:ext cx="2105319" cy="4477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65243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CDE785-E87E-89A8-2053-3DFECFC398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PCAT3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5E71F8E-FA7B-748B-4E2B-2E3D335B63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56701678"/>
              </p:ext>
            </p:extLst>
          </p:nvPr>
        </p:nvGraphicFramePr>
        <p:xfrm>
          <a:off x="5659778" y="2407898"/>
          <a:ext cx="2265363" cy="2452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265614" imgH="2453009" progId="Prism10.Document">
                  <p:embed/>
                </p:oleObj>
              </mc:Choice>
              <mc:Fallback>
                <p:oleObj name="Prism 10" r:id="rId2" imgW="2265614" imgH="245300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659778" y="2407898"/>
                        <a:ext cx="2265363" cy="2452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B62AB1A2-0414-B242-C22C-9E3874E9A22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3824" y="1514218"/>
            <a:ext cx="3305866" cy="224819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B7F21CD-F3D5-47C2-2409-DE1FEAA585D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39695" y="1082335"/>
            <a:ext cx="2953162" cy="46679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0ED7B81-5216-E31A-ABD3-BDF9F3C6266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39695" y="1514218"/>
            <a:ext cx="2905530" cy="7906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91685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56</TotalTime>
  <Words>88</Words>
  <Application>Microsoft Macintosh PowerPoint</Application>
  <PresentationFormat>Widescreen</PresentationFormat>
  <Paragraphs>48</Paragraphs>
  <Slides>1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3" baseType="lpstr">
      <vt:lpstr>Arial</vt:lpstr>
      <vt:lpstr>Calibri</vt:lpstr>
      <vt:lpstr>Calibri Light</vt:lpstr>
      <vt:lpstr>Office Theme</vt:lpstr>
      <vt:lpstr>Prism 10</vt:lpstr>
      <vt:lpstr>Western Blots of Human Heart Tissues </vt:lpstr>
      <vt:lpstr>GSR</vt:lpstr>
      <vt:lpstr>DMT1</vt:lpstr>
      <vt:lpstr>ATF4 </vt:lpstr>
      <vt:lpstr>Ferroportin-1</vt:lpstr>
      <vt:lpstr>NRF2 </vt:lpstr>
      <vt:lpstr>FLC</vt:lpstr>
      <vt:lpstr>VDAC</vt:lpstr>
      <vt:lpstr>LPCAT3</vt:lpstr>
      <vt:lpstr>APP</vt:lpstr>
      <vt:lpstr>HMOX1</vt:lpstr>
      <vt:lpstr>TFR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uman sample</dc:title>
  <dc:creator>Gawargi, Flobater I</dc:creator>
  <cp:lastModifiedBy>Mishra, Paras Kumar</cp:lastModifiedBy>
  <cp:revision>14</cp:revision>
  <dcterms:created xsi:type="dcterms:W3CDTF">2023-10-16T22:20:20Z</dcterms:created>
  <dcterms:modified xsi:type="dcterms:W3CDTF">2024-05-20T11:44:50Z</dcterms:modified>
</cp:coreProperties>
</file>